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62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1348" autoAdjust="0"/>
    <p:restoredTop sz="94694" autoAdjust="0"/>
  </p:normalViewPr>
  <p:slideViewPr>
    <p:cSldViewPr snapToGrid="0">
      <p:cViewPr varScale="1">
        <p:scale>
          <a:sx n="84" d="100"/>
          <a:sy n="84" d="100"/>
        </p:scale>
        <p:origin x="2576" y="18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tetsuyaokuda\Desktop\&#35542;&#25991;&#29992;&#12486;&#12441;&#12540;&#12479;&#12414;&#12392;&#12417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tetsuyaokuda\Desktop\&#35542;&#25991;&#29992;&#12486;&#12441;&#12540;&#12479;&#12414;&#12392;&#12417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lpr_human_serum IgE'!$B$5</c:f>
              <c:strCache>
                <c:ptCount val="1"/>
                <c:pt idx="0">
                  <c:v>A450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lpr_human_serum IgE'!$C$6:$C$31</c:f>
                <c:numCache>
                  <c:formatCode>General</c:formatCode>
                  <c:ptCount val="26"/>
                  <c:pt idx="0">
                    <c:v>2.0256686138984624E-3</c:v>
                  </c:pt>
                  <c:pt idx="1">
                    <c:v>1.7677669529663704E-3</c:v>
                  </c:pt>
                  <c:pt idx="2">
                    <c:v>1.2727922061357877E-3</c:v>
                  </c:pt>
                  <c:pt idx="3">
                    <c:v>1.4849242404917481E-3</c:v>
                  </c:pt>
                  <c:pt idx="4">
                    <c:v>1.1313708498984791E-3</c:v>
                  </c:pt>
                  <c:pt idx="5">
                    <c:v>2.1213203435596541E-4</c:v>
                  </c:pt>
                  <c:pt idx="6">
                    <c:v>3.5355339059327407E-3</c:v>
                  </c:pt>
                  <c:pt idx="7">
                    <c:v>7.0710678118656773E-5</c:v>
                  </c:pt>
                  <c:pt idx="8">
                    <c:v>1.0606601717798223E-3</c:v>
                  </c:pt>
                  <c:pt idx="9">
                    <c:v>3.5355339059326915E-4</c:v>
                  </c:pt>
                  <c:pt idx="10">
                    <c:v>4.932882862316244E-3</c:v>
                  </c:pt>
                  <c:pt idx="11">
                    <c:v>2.1213203435596541E-4</c:v>
                  </c:pt>
                  <c:pt idx="12">
                    <c:v>4.9497474683058275E-4</c:v>
                  </c:pt>
                  <c:pt idx="13">
                    <c:v>5.0934598588124125E-3</c:v>
                  </c:pt>
                  <c:pt idx="14">
                    <c:v>5.6568542494923955E-4</c:v>
                  </c:pt>
                  <c:pt idx="15">
                    <c:v>7.0710678118656773E-5</c:v>
                  </c:pt>
                  <c:pt idx="16">
                    <c:v>2.4748737341529184E-3</c:v>
                  </c:pt>
                  <c:pt idx="17">
                    <c:v>3.5355339059327408E-4</c:v>
                  </c:pt>
                  <c:pt idx="18">
                    <c:v>2.1213203435596541E-4</c:v>
                  </c:pt>
                  <c:pt idx="19">
                    <c:v>2.1213203435596446E-3</c:v>
                  </c:pt>
                  <c:pt idx="20">
                    <c:v>1.7677669529663704E-3</c:v>
                  </c:pt>
                  <c:pt idx="21">
                    <c:v>7.7781745930520008E-4</c:v>
                  </c:pt>
                  <c:pt idx="22">
                    <c:v>9.1923881554251358E-4</c:v>
                  </c:pt>
                  <c:pt idx="23">
                    <c:v>2.5153992393521483E-2</c:v>
                  </c:pt>
                  <c:pt idx="24">
                    <c:v>2.1079215671683171E-3</c:v>
                  </c:pt>
                  <c:pt idx="25">
                    <c:v>1.6370705543744908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lpr_human_serum IgE'!$A$6:$A$31</c:f>
              <c:strCache>
                <c:ptCount val="26"/>
                <c:pt idx="0">
                  <c:v>αGalCer</c:v>
                </c:pt>
                <c:pt idx="1">
                  <c:v>LacCer</c:v>
                </c:pt>
                <c:pt idx="2">
                  <c:v>LN</c:v>
                </c:pt>
                <c:pt idx="3">
                  <c:v>Gb3</c:v>
                </c:pt>
                <c:pt idx="4">
                  <c:v>iGb3</c:v>
                </c:pt>
                <c:pt idx="5">
                  <c:v>Gb4</c:v>
                </c:pt>
                <c:pt idx="6">
                  <c:v>GA2</c:v>
                </c:pt>
                <c:pt idx="7">
                  <c:v>GA1</c:v>
                </c:pt>
                <c:pt idx="8">
                  <c:v>GM3</c:v>
                </c:pt>
                <c:pt idx="9">
                  <c:v>GM2</c:v>
                </c:pt>
                <c:pt idx="10">
                  <c:v>GM2-Gc</c:v>
                </c:pt>
                <c:pt idx="11">
                  <c:v>GM1</c:v>
                </c:pt>
                <c:pt idx="12">
                  <c:v>GD3</c:v>
                </c:pt>
                <c:pt idx="13">
                  <c:v>GD2</c:v>
                </c:pt>
                <c:pt idx="14">
                  <c:v>GD1a</c:v>
                </c:pt>
                <c:pt idx="15">
                  <c:v>GT1b</c:v>
                </c:pt>
                <c:pt idx="16">
                  <c:v>3SLN</c:v>
                </c:pt>
                <c:pt idx="17">
                  <c:v>6SLN</c:v>
                </c:pt>
                <c:pt idx="18">
                  <c:v>TG-B</c:v>
                </c:pt>
                <c:pt idx="19">
                  <c:v>TG-P</c:v>
                </c:pt>
                <c:pt idx="20">
                  <c:v>Fetuin</c:v>
                </c:pt>
                <c:pt idx="21">
                  <c:v>a-Fetuin</c:v>
                </c:pt>
                <c:pt idx="22">
                  <c:v>HL60</c:v>
                </c:pt>
                <c:pt idx="23">
                  <c:v>ssDNA</c:v>
                </c:pt>
                <c:pt idx="24">
                  <c:v>dsDNA</c:v>
                </c:pt>
                <c:pt idx="25">
                  <c:v>Blank</c:v>
                </c:pt>
              </c:strCache>
            </c:strRef>
          </c:cat>
          <c:val>
            <c:numRef>
              <c:f>'lpr_human_serum IgE'!$B$6:$B$31</c:f>
              <c:numCache>
                <c:formatCode>General</c:formatCode>
                <c:ptCount val="26"/>
                <c:pt idx="0">
                  <c:v>6.356666666666666E-2</c:v>
                </c:pt>
                <c:pt idx="1">
                  <c:v>6.5250000000000002E-2</c:v>
                </c:pt>
                <c:pt idx="2">
                  <c:v>5.7800000000000004E-2</c:v>
                </c:pt>
                <c:pt idx="3">
                  <c:v>5.2449999999999997E-2</c:v>
                </c:pt>
                <c:pt idx="4">
                  <c:v>5.3800000000000001E-2</c:v>
                </c:pt>
                <c:pt idx="5">
                  <c:v>5.1549999999999999E-2</c:v>
                </c:pt>
                <c:pt idx="6">
                  <c:v>6.7199999999999996E-2</c:v>
                </c:pt>
                <c:pt idx="7">
                  <c:v>5.815E-2</c:v>
                </c:pt>
                <c:pt idx="8">
                  <c:v>5.425E-2</c:v>
                </c:pt>
                <c:pt idx="9">
                  <c:v>5.2449999999999997E-2</c:v>
                </c:pt>
                <c:pt idx="10">
                  <c:v>6.6033333333333347E-2</c:v>
                </c:pt>
                <c:pt idx="11">
                  <c:v>5.2650000000000002E-2</c:v>
                </c:pt>
                <c:pt idx="12">
                  <c:v>5.2849999999999994E-2</c:v>
                </c:pt>
                <c:pt idx="13">
                  <c:v>6.0666666666666667E-2</c:v>
                </c:pt>
                <c:pt idx="14">
                  <c:v>5.1199999999999996E-2</c:v>
                </c:pt>
                <c:pt idx="15">
                  <c:v>5.2350000000000001E-2</c:v>
                </c:pt>
                <c:pt idx="16">
                  <c:v>6.8049999999999999E-2</c:v>
                </c:pt>
                <c:pt idx="17">
                  <c:v>5.2850000000000001E-2</c:v>
                </c:pt>
                <c:pt idx="18">
                  <c:v>5.8550000000000005E-2</c:v>
                </c:pt>
                <c:pt idx="19">
                  <c:v>6.5299999999999997E-2</c:v>
                </c:pt>
                <c:pt idx="20">
                  <c:v>6.0150000000000002E-2</c:v>
                </c:pt>
                <c:pt idx="21">
                  <c:v>6.0649999999999996E-2</c:v>
                </c:pt>
                <c:pt idx="22">
                  <c:v>5.9249999999999997E-2</c:v>
                </c:pt>
                <c:pt idx="23">
                  <c:v>9.4299999999999995E-2</c:v>
                </c:pt>
                <c:pt idx="24">
                  <c:v>7.9725000000000004E-2</c:v>
                </c:pt>
                <c:pt idx="25">
                  <c:v>5.9100000000000007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047-9142-AA16-0AD8C170E69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182281728"/>
        <c:axId val="182283264"/>
      </c:barChart>
      <c:catAx>
        <c:axId val="1822817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82283264"/>
        <c:crosses val="autoZero"/>
        <c:auto val="1"/>
        <c:lblAlgn val="ctr"/>
        <c:lblOffset val="100"/>
        <c:noMultiLvlLbl val="0"/>
      </c:catAx>
      <c:valAx>
        <c:axId val="182283264"/>
        <c:scaling>
          <c:orientation val="minMax"/>
          <c:max val="0.6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82281728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lpr_human_serum IgE'!$B$35</c:f>
              <c:strCache>
                <c:ptCount val="1"/>
                <c:pt idx="0">
                  <c:v>A450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lpr_human_serum IgE'!$C$36:$C$62</c:f>
                <c:numCache>
                  <c:formatCode>General</c:formatCode>
                  <c:ptCount val="27"/>
                  <c:pt idx="0">
                    <c:v>1.687315422004243E-2</c:v>
                  </c:pt>
                  <c:pt idx="1">
                    <c:v>0</c:v>
                  </c:pt>
                  <c:pt idx="2">
                    <c:v>5.3033008588991067E-3</c:v>
                  </c:pt>
                  <c:pt idx="3">
                    <c:v>1.979898987322331E-3</c:v>
                  </c:pt>
                  <c:pt idx="4">
                    <c:v>1.4142135623730864E-4</c:v>
                  </c:pt>
                  <c:pt idx="5">
                    <c:v>9.1923881554251358E-4</c:v>
                  </c:pt>
                  <c:pt idx="6">
                    <c:v>3.5355339059327408E-4</c:v>
                  </c:pt>
                  <c:pt idx="7">
                    <c:v>1.6263455967290617E-3</c:v>
                  </c:pt>
                  <c:pt idx="8">
                    <c:v>5.9396969619669978E-3</c:v>
                  </c:pt>
                  <c:pt idx="9">
                    <c:v>9.899494936611655E-4</c:v>
                  </c:pt>
                  <c:pt idx="10">
                    <c:v>1.7677669529663704E-3</c:v>
                  </c:pt>
                  <c:pt idx="11">
                    <c:v>1.7182694782833092E-2</c:v>
                  </c:pt>
                  <c:pt idx="12">
                    <c:v>1.4849242404917481E-3</c:v>
                  </c:pt>
                  <c:pt idx="13">
                    <c:v>1.1768602295939823E-3</c:v>
                  </c:pt>
                  <c:pt idx="14">
                    <c:v>3.7476659402887014E-3</c:v>
                  </c:pt>
                  <c:pt idx="15">
                    <c:v>2.1213203435596541E-4</c:v>
                  </c:pt>
                  <c:pt idx="16">
                    <c:v>2.1213203435596446E-3</c:v>
                  </c:pt>
                  <c:pt idx="17">
                    <c:v>1.5556349186104049E-3</c:v>
                  </c:pt>
                  <c:pt idx="18">
                    <c:v>5.0774009099144391E-3</c:v>
                  </c:pt>
                  <c:pt idx="19">
                    <c:v>7.9650800372626507E-3</c:v>
                  </c:pt>
                  <c:pt idx="20">
                    <c:v>1.3435028842544445E-3</c:v>
                  </c:pt>
                  <c:pt idx="21">
                    <c:v>1.979898987322331E-3</c:v>
                  </c:pt>
                  <c:pt idx="22">
                    <c:v>2.4041630560342618E-3</c:v>
                  </c:pt>
                  <c:pt idx="23">
                    <c:v>7.4848179670583825E-3</c:v>
                  </c:pt>
                  <c:pt idx="24">
                    <c:v>2.426245384677045E-3</c:v>
                  </c:pt>
                  <c:pt idx="25">
                    <c:v>3.7562170686299082E-3</c:v>
                  </c:pt>
                  <c:pt idx="26">
                    <c:v>2.5064915718988555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lpr_human_serum IgE'!$A$36:$A$61</c:f>
              <c:strCache>
                <c:ptCount val="26"/>
                <c:pt idx="0">
                  <c:v>αGalCer</c:v>
                </c:pt>
                <c:pt idx="1">
                  <c:v>LacCer</c:v>
                </c:pt>
                <c:pt idx="2">
                  <c:v>LN</c:v>
                </c:pt>
                <c:pt idx="3">
                  <c:v>Gb3</c:v>
                </c:pt>
                <c:pt idx="4">
                  <c:v>iGb3</c:v>
                </c:pt>
                <c:pt idx="5">
                  <c:v>Gb4</c:v>
                </c:pt>
                <c:pt idx="6">
                  <c:v>GA2</c:v>
                </c:pt>
                <c:pt idx="7">
                  <c:v>GA1</c:v>
                </c:pt>
                <c:pt idx="8">
                  <c:v>GM3</c:v>
                </c:pt>
                <c:pt idx="9">
                  <c:v>GM2</c:v>
                </c:pt>
                <c:pt idx="10">
                  <c:v>GM2-Gc</c:v>
                </c:pt>
                <c:pt idx="11">
                  <c:v>GM1</c:v>
                </c:pt>
                <c:pt idx="12">
                  <c:v>GD3</c:v>
                </c:pt>
                <c:pt idx="13">
                  <c:v>GD2</c:v>
                </c:pt>
                <c:pt idx="14">
                  <c:v>GD1a</c:v>
                </c:pt>
                <c:pt idx="15">
                  <c:v>GT1b</c:v>
                </c:pt>
                <c:pt idx="16">
                  <c:v>3SLN</c:v>
                </c:pt>
                <c:pt idx="17">
                  <c:v>6SLN</c:v>
                </c:pt>
                <c:pt idx="18">
                  <c:v>TG-B</c:v>
                </c:pt>
                <c:pt idx="19">
                  <c:v>TG-P</c:v>
                </c:pt>
                <c:pt idx="20">
                  <c:v>Fetuin</c:v>
                </c:pt>
                <c:pt idx="21">
                  <c:v>a-Fetuin</c:v>
                </c:pt>
                <c:pt idx="22">
                  <c:v>HL60</c:v>
                </c:pt>
                <c:pt idx="23">
                  <c:v>ssDNA</c:v>
                </c:pt>
                <c:pt idx="24">
                  <c:v>dsDNA</c:v>
                </c:pt>
                <c:pt idx="25">
                  <c:v>Blank</c:v>
                </c:pt>
              </c:strCache>
            </c:strRef>
          </c:cat>
          <c:val>
            <c:numRef>
              <c:f>'lpr_human_serum IgE'!$B$36:$B$61</c:f>
              <c:numCache>
                <c:formatCode>General</c:formatCode>
                <c:ptCount val="26"/>
                <c:pt idx="0">
                  <c:v>7.383333333333332E-2</c:v>
                </c:pt>
                <c:pt idx="1">
                  <c:v>6.0999999999999999E-2</c:v>
                </c:pt>
                <c:pt idx="2">
                  <c:v>5.9249999999999997E-2</c:v>
                </c:pt>
                <c:pt idx="3">
                  <c:v>5.5500000000000001E-2</c:v>
                </c:pt>
                <c:pt idx="4">
                  <c:v>5.5300000000000002E-2</c:v>
                </c:pt>
                <c:pt idx="5">
                  <c:v>5.2150000000000002E-2</c:v>
                </c:pt>
                <c:pt idx="6">
                  <c:v>6.055E-2</c:v>
                </c:pt>
                <c:pt idx="7">
                  <c:v>5.8749999999999997E-2</c:v>
                </c:pt>
                <c:pt idx="8">
                  <c:v>6.5100000000000005E-2</c:v>
                </c:pt>
                <c:pt idx="9">
                  <c:v>5.5E-2</c:v>
                </c:pt>
                <c:pt idx="10">
                  <c:v>6.1350000000000002E-2</c:v>
                </c:pt>
                <c:pt idx="11">
                  <c:v>6.8150000000000002E-2</c:v>
                </c:pt>
                <c:pt idx="12">
                  <c:v>5.5150000000000005E-2</c:v>
                </c:pt>
                <c:pt idx="13">
                  <c:v>5.439999999999999E-2</c:v>
                </c:pt>
                <c:pt idx="14">
                  <c:v>5.6750000000000002E-2</c:v>
                </c:pt>
                <c:pt idx="15">
                  <c:v>5.5650000000000005E-2</c:v>
                </c:pt>
                <c:pt idx="16">
                  <c:v>6.7299999999999999E-2</c:v>
                </c:pt>
                <c:pt idx="17">
                  <c:v>5.5099999999999996E-2</c:v>
                </c:pt>
                <c:pt idx="18">
                  <c:v>6.5799999999999997E-2</c:v>
                </c:pt>
                <c:pt idx="19">
                  <c:v>7.2024999999999992E-2</c:v>
                </c:pt>
                <c:pt idx="20">
                  <c:v>5.7050000000000003E-2</c:v>
                </c:pt>
                <c:pt idx="21">
                  <c:v>5.7200000000000001E-2</c:v>
                </c:pt>
                <c:pt idx="22">
                  <c:v>5.8099999999999999E-2</c:v>
                </c:pt>
                <c:pt idx="23">
                  <c:v>7.8424999999999995E-2</c:v>
                </c:pt>
                <c:pt idx="24">
                  <c:v>7.5299999999999992E-2</c:v>
                </c:pt>
                <c:pt idx="25">
                  <c:v>5.7474999999999998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32F-7640-8361-7B5DFCE0714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82299648"/>
        <c:axId val="182461184"/>
      </c:barChart>
      <c:catAx>
        <c:axId val="1822996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82461184"/>
        <c:crosses val="autoZero"/>
        <c:auto val="1"/>
        <c:lblAlgn val="ctr"/>
        <c:lblOffset val="100"/>
        <c:noMultiLvlLbl val="0"/>
      </c:catAx>
      <c:valAx>
        <c:axId val="182461184"/>
        <c:scaling>
          <c:orientation val="minMax"/>
          <c:max val="0.6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82299648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011832B-AEF3-AA48-81B0-C0AA61C1255C}" type="datetimeFigureOut">
              <a:rPr kumimoji="1" lang="ja-JP" altLang="en-US" smtClean="0"/>
              <a:t>2024/7/2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F6FC239-CEAB-8948-BB7F-2A595F3D5D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9508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0D360-59BC-9348-A731-C50E33062698}" type="datetimeFigureOut">
              <a:rPr kumimoji="1" lang="ja-JP" altLang="en-US" smtClean="0"/>
              <a:t>2024/7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82A9B2-FCC8-2748-A8E6-0E309DB0A9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31401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0D360-59BC-9348-A731-C50E33062698}" type="datetimeFigureOut">
              <a:rPr kumimoji="1" lang="ja-JP" altLang="en-US" smtClean="0"/>
              <a:t>2024/7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82A9B2-FCC8-2748-A8E6-0E309DB0A9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60087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0D360-59BC-9348-A731-C50E33062698}" type="datetimeFigureOut">
              <a:rPr kumimoji="1" lang="ja-JP" altLang="en-US" smtClean="0"/>
              <a:t>2024/7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82A9B2-FCC8-2748-A8E6-0E309DB0A9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95733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0D360-59BC-9348-A731-C50E33062698}" type="datetimeFigureOut">
              <a:rPr kumimoji="1" lang="ja-JP" altLang="en-US" smtClean="0"/>
              <a:t>2024/7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82A9B2-FCC8-2748-A8E6-0E309DB0A9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36363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0D360-59BC-9348-A731-C50E33062698}" type="datetimeFigureOut">
              <a:rPr kumimoji="1" lang="ja-JP" altLang="en-US" smtClean="0"/>
              <a:t>2024/7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82A9B2-FCC8-2748-A8E6-0E309DB0A9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66078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0D360-59BC-9348-A731-C50E33062698}" type="datetimeFigureOut">
              <a:rPr kumimoji="1" lang="ja-JP" altLang="en-US" smtClean="0"/>
              <a:t>2024/7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82A9B2-FCC8-2748-A8E6-0E309DB0A9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8395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0D360-59BC-9348-A731-C50E33062698}" type="datetimeFigureOut">
              <a:rPr kumimoji="1" lang="ja-JP" altLang="en-US" smtClean="0"/>
              <a:t>2024/7/2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82A9B2-FCC8-2748-A8E6-0E309DB0A9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20886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0D360-59BC-9348-A731-C50E33062698}" type="datetimeFigureOut">
              <a:rPr kumimoji="1" lang="ja-JP" altLang="en-US" smtClean="0"/>
              <a:t>2024/7/2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82A9B2-FCC8-2748-A8E6-0E309DB0A9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18250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0D360-59BC-9348-A731-C50E33062698}" type="datetimeFigureOut">
              <a:rPr kumimoji="1" lang="ja-JP" altLang="en-US" smtClean="0"/>
              <a:t>2024/7/2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82A9B2-FCC8-2748-A8E6-0E309DB0A9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13892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0D360-59BC-9348-A731-C50E33062698}" type="datetimeFigureOut">
              <a:rPr kumimoji="1" lang="ja-JP" altLang="en-US" smtClean="0"/>
              <a:t>2024/7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82A9B2-FCC8-2748-A8E6-0E309DB0A9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37971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0D360-59BC-9348-A731-C50E33062698}" type="datetimeFigureOut">
              <a:rPr kumimoji="1" lang="ja-JP" altLang="en-US" smtClean="0"/>
              <a:t>2024/7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82A9B2-FCC8-2748-A8E6-0E309DB0A9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84001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E40D360-59BC-9348-A731-C50E33062698}" type="datetimeFigureOut">
              <a:rPr kumimoji="1" lang="ja-JP" altLang="en-US" smtClean="0"/>
              <a:t>2024/7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782A9B2-FCC8-2748-A8E6-0E309DB0A9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81805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528A61DF-7856-FDA2-0D1A-9D1128A47EA2}"/>
              </a:ext>
            </a:extLst>
          </p:cNvPr>
          <p:cNvGrpSpPr/>
          <p:nvPr/>
        </p:nvGrpSpPr>
        <p:grpSpPr>
          <a:xfrm>
            <a:off x="456318" y="2907768"/>
            <a:ext cx="5789003" cy="4090465"/>
            <a:chOff x="456318" y="3858636"/>
            <a:chExt cx="5789003" cy="4090465"/>
          </a:xfrm>
        </p:grpSpPr>
        <p:grpSp>
          <p:nvGrpSpPr>
            <p:cNvPr id="25" name="グループ化 24">
              <a:extLst>
                <a:ext uri="{FF2B5EF4-FFF2-40B4-BE49-F238E27FC236}">
                  <a16:creationId xmlns:a16="http://schemas.microsoft.com/office/drawing/2014/main" id="{7A8DEA3F-9E64-78B5-AA53-02DFE0CFF3BE}"/>
                </a:ext>
              </a:extLst>
            </p:cNvPr>
            <p:cNvGrpSpPr/>
            <p:nvPr/>
          </p:nvGrpSpPr>
          <p:grpSpPr>
            <a:xfrm>
              <a:off x="632007" y="4072724"/>
              <a:ext cx="5613314" cy="1800000"/>
              <a:chOff x="632007" y="4072724"/>
              <a:chExt cx="5613314" cy="1800000"/>
            </a:xfrm>
          </p:grpSpPr>
          <p:grpSp>
            <p:nvGrpSpPr>
              <p:cNvPr id="20" name="グループ化 19">
                <a:extLst>
                  <a:ext uri="{FF2B5EF4-FFF2-40B4-BE49-F238E27FC236}">
                    <a16:creationId xmlns:a16="http://schemas.microsoft.com/office/drawing/2014/main" id="{3116B167-90F7-5634-541C-E6E43982EF08}"/>
                  </a:ext>
                </a:extLst>
              </p:cNvPr>
              <p:cNvGrpSpPr/>
              <p:nvPr/>
            </p:nvGrpSpPr>
            <p:grpSpPr>
              <a:xfrm>
                <a:off x="845321" y="4072724"/>
                <a:ext cx="5400000" cy="1800000"/>
                <a:chOff x="729000" y="4873748"/>
                <a:chExt cx="5400000" cy="1800000"/>
              </a:xfrm>
            </p:grpSpPr>
            <p:grpSp>
              <p:nvGrpSpPr>
                <p:cNvPr id="12" name="グループ化 11">
                  <a:extLst>
                    <a:ext uri="{FF2B5EF4-FFF2-40B4-BE49-F238E27FC236}">
                      <a16:creationId xmlns:a16="http://schemas.microsoft.com/office/drawing/2014/main" id="{1C551AFE-4400-6BE2-A51D-FB056338421E}"/>
                    </a:ext>
                  </a:extLst>
                </p:cNvPr>
                <p:cNvGrpSpPr/>
                <p:nvPr/>
              </p:nvGrpSpPr>
              <p:grpSpPr>
                <a:xfrm>
                  <a:off x="729000" y="4873748"/>
                  <a:ext cx="5400000" cy="1800000"/>
                  <a:chOff x="729000" y="4873748"/>
                  <a:chExt cx="5400000" cy="1800000"/>
                </a:xfrm>
              </p:grpSpPr>
              <p:cxnSp>
                <p:nvCxnSpPr>
                  <p:cNvPr id="9" name="直線コネクタ 8">
                    <a:extLst>
                      <a:ext uri="{FF2B5EF4-FFF2-40B4-BE49-F238E27FC236}">
                        <a16:creationId xmlns:a16="http://schemas.microsoft.com/office/drawing/2014/main" id="{D8BEF380-2D46-EBEB-1180-D6CB4AB5581B}"/>
                      </a:ext>
                    </a:extLst>
                  </p:cNvPr>
                  <p:cNvCxnSpPr/>
                  <p:nvPr/>
                </p:nvCxnSpPr>
                <p:spPr>
                  <a:xfrm>
                    <a:off x="1097280" y="5921798"/>
                    <a:ext cx="4876800" cy="0"/>
                  </a:xfrm>
                  <a:prstGeom prst="line">
                    <a:avLst/>
                  </a:prstGeom>
                  <a:ln w="9525">
                    <a:solidFill>
                      <a:schemeClr val="bg1">
                        <a:lumMod val="50000"/>
                      </a:schemeClr>
                    </a:solidFill>
                    <a:prstDash val="dash"/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graphicFrame>
                <p:nvGraphicFramePr>
                  <p:cNvPr id="2" name="グラフ 1">
                    <a:extLst>
                      <a:ext uri="{FF2B5EF4-FFF2-40B4-BE49-F238E27FC236}">
                        <a16:creationId xmlns:a16="http://schemas.microsoft.com/office/drawing/2014/main" id="{82A9FF8E-74F3-99FB-6A75-FAAB4DD43EF9}"/>
                      </a:ext>
                    </a:extLst>
                  </p:cNvPr>
                  <p:cNvGraphicFramePr>
                    <a:graphicFrameLocks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1492117037"/>
                      </p:ext>
                    </p:extLst>
                  </p:nvPr>
                </p:nvGraphicFramePr>
                <p:xfrm>
                  <a:off x="729000" y="4873748"/>
                  <a:ext cx="5400000" cy="1800000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2"/>
                  </a:graphicData>
                </a:graphic>
              </p:graphicFrame>
            </p:grpSp>
            <p:sp>
              <p:nvSpPr>
                <p:cNvPr id="18" name="テキスト ボックス 17">
                  <a:extLst>
                    <a:ext uri="{FF2B5EF4-FFF2-40B4-BE49-F238E27FC236}">
                      <a16:creationId xmlns:a16="http://schemas.microsoft.com/office/drawing/2014/main" id="{1AD4FD66-166F-969B-24CB-6949D443427A}"/>
                    </a:ext>
                  </a:extLst>
                </p:cNvPr>
                <p:cNvSpPr txBox="1"/>
                <p:nvPr/>
              </p:nvSpPr>
              <p:spPr>
                <a:xfrm>
                  <a:off x="4824382" y="4875104"/>
                  <a:ext cx="11304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RL/lpr IgE</a:t>
                  </a:r>
                  <a:endParaRPr kumimoji="1" lang="ja-JP" altLang="en-US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3" name="テキスト ボックス 22">
                <a:extLst>
                  <a:ext uri="{FF2B5EF4-FFF2-40B4-BE49-F238E27FC236}">
                    <a16:creationId xmlns:a16="http://schemas.microsoft.com/office/drawing/2014/main" id="{7A2C0A5C-89DA-A125-FC80-0B8DAD279112}"/>
                  </a:ext>
                </a:extLst>
              </p:cNvPr>
              <p:cNvSpPr txBox="1"/>
              <p:nvPr/>
            </p:nvSpPr>
            <p:spPr>
              <a:xfrm rot="16200000">
                <a:off x="514507" y="4558296"/>
                <a:ext cx="48122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A450</a:t>
                </a:r>
                <a:endParaRPr kumimoji="1" lang="ja-JP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10" name="直線コネクタ 9">
              <a:extLst>
                <a:ext uri="{FF2B5EF4-FFF2-40B4-BE49-F238E27FC236}">
                  <a16:creationId xmlns:a16="http://schemas.microsoft.com/office/drawing/2014/main" id="{A9BAA5A5-5625-E221-44F3-731B6302694C}"/>
                </a:ext>
              </a:extLst>
            </p:cNvPr>
            <p:cNvCxnSpPr/>
            <p:nvPr/>
          </p:nvCxnSpPr>
          <p:spPr>
            <a:xfrm>
              <a:off x="1223242" y="7210183"/>
              <a:ext cx="4876800" cy="0"/>
            </a:xfrm>
            <a:prstGeom prst="line">
              <a:avLst/>
            </a:prstGeom>
            <a:ln w="9525">
              <a:solidFill>
                <a:schemeClr val="bg1">
                  <a:lumMod val="50000"/>
                </a:schemeClr>
              </a:solidFill>
              <a:prstDash val="dash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aphicFrame>
          <p:nvGraphicFramePr>
            <p:cNvPr id="3" name="グラフ 2">
              <a:extLst>
                <a:ext uri="{FF2B5EF4-FFF2-40B4-BE49-F238E27FC236}">
                  <a16:creationId xmlns:a16="http://schemas.microsoft.com/office/drawing/2014/main" id="{1994A6D6-9A94-14BE-2919-3F6B52CD7F3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643982182"/>
                </p:ext>
              </p:extLst>
            </p:nvPr>
          </p:nvGraphicFramePr>
          <p:xfrm>
            <a:off x="845321" y="6149101"/>
            <a:ext cx="5400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1D59FF43-1F33-3E51-0D9B-6C702CB06E60}"/>
                </a:ext>
              </a:extLst>
            </p:cNvPr>
            <p:cNvSpPr txBox="1"/>
            <p:nvPr/>
          </p:nvSpPr>
          <p:spPr>
            <a:xfrm>
              <a:off x="4990396" y="6149101"/>
              <a:ext cx="108074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Human IgE</a:t>
              </a:r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2378EFF8-6B6B-BBF1-5966-3C3AF9E3C05A}"/>
                </a:ext>
              </a:extLst>
            </p:cNvPr>
            <p:cNvSpPr txBox="1"/>
            <p:nvPr/>
          </p:nvSpPr>
          <p:spPr>
            <a:xfrm rot="16200000">
              <a:off x="514507" y="6632045"/>
              <a:ext cx="4812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450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EDF11915-4BED-B6FF-F82B-285E98A5AD34}"/>
                </a:ext>
              </a:extLst>
            </p:cNvPr>
            <p:cNvSpPr txBox="1"/>
            <p:nvPr/>
          </p:nvSpPr>
          <p:spPr>
            <a:xfrm>
              <a:off x="456318" y="3858636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1" lang="ja-JP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14A20C62-66C4-0AB1-8EEB-FBC4BC8E70B0}"/>
                </a:ext>
              </a:extLst>
            </p:cNvPr>
            <p:cNvSpPr txBox="1"/>
            <p:nvPr/>
          </p:nvSpPr>
          <p:spPr>
            <a:xfrm>
              <a:off x="456318" y="5933657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1" lang="ja-JP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A4CDDB33-1197-3597-3E8F-4C3C2AFF25D3}"/>
              </a:ext>
            </a:extLst>
          </p:cNvPr>
          <p:cNvSpPr txBox="1"/>
          <p:nvPr/>
        </p:nvSpPr>
        <p:spPr>
          <a:xfrm>
            <a:off x="313603" y="7285648"/>
            <a:ext cx="6230794" cy="1615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1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ig. S1. Reactivity of serum </a:t>
            </a:r>
            <a:r>
              <a:rPr lang="en-US" altLang="ja-JP" sz="11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IgE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from MRL/</a:t>
            </a:r>
            <a:r>
              <a:rPr lang="en-US" altLang="ja-JP" sz="11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lpr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mice and humans to various carbohydrate antigens.</a:t>
            </a:r>
            <a:endParaRPr lang="ja-JP" altLang="ja-JP" sz="1100" kern="10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 indent="139700" algn="just"/>
            <a:r>
              <a:rPr lang="en-US" altLang="ja-JP" sz="11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ooled sera samples from MRL/</a:t>
            </a:r>
            <a:r>
              <a:rPr lang="en-US" altLang="ja-JP" sz="11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lpr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mice (A) and healthy human donors (B) were incubated in microtiter plate wells coated with various carbohydrate antigens, and the reactivity of the </a:t>
            </a:r>
            <a:r>
              <a:rPr lang="en-US" altLang="ja-JP" sz="11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IgE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antibodies in the serum to the wells was detected by ELISA. Sera for the ELISA were used at a 1:50 dilution. The chemical structures of the glycosphingolipids used in this analysis are shown in Supplementary Table S1. Error bars indicate the mean ± standard deviation (n=2). Abbreviations: TG-B, bovine thyroglobulin; TG-P, porcine thyroglobulin; a-Fetuin, </a:t>
            </a:r>
            <a:r>
              <a:rPr lang="en-US" altLang="ja-JP" sz="11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sialo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-fetuin; HL60, glycoproteins extracted from HL60 cells; ssDNA, single-stranded DNA; dsDNA, double-stranded DNA. Details of the glycan structure of the glycoproteins are described in Fig. 3.</a:t>
            </a:r>
            <a:endParaRPr lang="ja-JP" altLang="ja-JP" sz="1100" kern="10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463911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38</TotalTime>
  <Words>168</Words>
  <Application>Microsoft Macintosh PowerPoint</Application>
  <PresentationFormat>A4 210 x 297 mm</PresentationFormat>
  <Paragraphs>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ptos</vt:lpstr>
      <vt:lpstr>Aptos Display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/>
  <cp:lastModifiedBy>奥田徹哉</cp:lastModifiedBy>
  <cp:revision>76</cp:revision>
  <cp:lastPrinted>2024-07-19T06:08:08Z</cp:lastPrinted>
  <dcterms:created xsi:type="dcterms:W3CDTF">2024-05-16T02:10:09Z</dcterms:created>
  <dcterms:modified xsi:type="dcterms:W3CDTF">2024-07-23T05:24:0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ddc55989-3c9e-4466-8514-eac6f80f6373_Enabled">
    <vt:lpwstr>true</vt:lpwstr>
  </property>
  <property fmtid="{D5CDD505-2E9C-101B-9397-08002B2CF9AE}" pid="3" name="MSIP_Label_ddc55989-3c9e-4466-8514-eac6f80f6373_SetDate">
    <vt:lpwstr>2024-05-16T02:16:01Z</vt:lpwstr>
  </property>
  <property fmtid="{D5CDD505-2E9C-101B-9397-08002B2CF9AE}" pid="4" name="MSIP_Label_ddc55989-3c9e-4466-8514-eac6f80f6373_Method">
    <vt:lpwstr>Privileged</vt:lpwstr>
  </property>
  <property fmtid="{D5CDD505-2E9C-101B-9397-08002B2CF9AE}" pid="5" name="MSIP_Label_ddc55989-3c9e-4466-8514-eac6f80f6373_Name">
    <vt:lpwstr>ddc55989-3c9e-4466-8514-eac6f80f6373</vt:lpwstr>
  </property>
  <property fmtid="{D5CDD505-2E9C-101B-9397-08002B2CF9AE}" pid="6" name="MSIP_Label_ddc55989-3c9e-4466-8514-eac6f80f6373_SiteId">
    <vt:lpwstr>18a7fec8-652f-409b-8369-272d9ce80620</vt:lpwstr>
  </property>
  <property fmtid="{D5CDD505-2E9C-101B-9397-08002B2CF9AE}" pid="7" name="MSIP_Label_ddc55989-3c9e-4466-8514-eac6f80f6373_ActionId">
    <vt:lpwstr>80816282-7569-4db4-ba1a-5e9fca714d26</vt:lpwstr>
  </property>
  <property fmtid="{D5CDD505-2E9C-101B-9397-08002B2CF9AE}" pid="8" name="MSIP_Label_ddc55989-3c9e-4466-8514-eac6f80f6373_ContentBits">
    <vt:lpwstr>0</vt:lpwstr>
  </property>
</Properties>
</file>